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8AA06-D316-4FBE-BC57-6C88A3E182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6A1D6-C114-4881-A431-F136815396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CA1C0-F840-4EA3-9FA8-601430F6BB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791114-FA14-416D-A234-B678A97571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9D113-5A80-496B-AFA6-F411847BA1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5EFFC-D9D9-45AB-B8B9-C4AA997DCA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5B34C-15F1-4610-8FAF-B609320F29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08D18-EDE8-446E-8D08-9BD1693766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201C5-0C84-4743-9546-2D24BEC976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477FB-4310-4D01-AEC2-C1034322DC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68D66-C308-4F16-AB23-9AAC355EBF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C6AD68-DE1E-4345-852F-5DD5EF3EC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91544E-2ABB-4B0C-AF29-24A7DCF0365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5 CuadroTexto"/>
          <p:cNvSpPr/>
          <p:nvPr/>
        </p:nvSpPr>
        <p:spPr>
          <a:xfrm>
            <a:off x="997920" y="1625760"/>
            <a:ext cx="49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15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6 CuadroTexto"/>
          <p:cNvSpPr/>
          <p:nvPr/>
        </p:nvSpPr>
        <p:spPr>
          <a:xfrm>
            <a:off x="1064880" y="184320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82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7 CuadroTexto"/>
          <p:cNvSpPr/>
          <p:nvPr/>
        </p:nvSpPr>
        <p:spPr>
          <a:xfrm>
            <a:off x="1075680" y="231300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49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8 CuadroTexto"/>
          <p:cNvSpPr/>
          <p:nvPr/>
        </p:nvSpPr>
        <p:spPr>
          <a:xfrm>
            <a:off x="1053720" y="25909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37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9 CuadroTexto"/>
          <p:cNvSpPr/>
          <p:nvPr/>
        </p:nvSpPr>
        <p:spPr>
          <a:xfrm>
            <a:off x="1064880" y="310500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26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10 CuadroTexto"/>
          <p:cNvSpPr/>
          <p:nvPr/>
        </p:nvSpPr>
        <p:spPr>
          <a:xfrm>
            <a:off x="1053720" y="342432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9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11 CuadroTexto"/>
          <p:cNvSpPr/>
          <p:nvPr/>
        </p:nvSpPr>
        <p:spPr>
          <a:xfrm>
            <a:off x="1053720" y="377496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15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12 CuadroTexto"/>
          <p:cNvSpPr/>
          <p:nvPr/>
        </p:nvSpPr>
        <p:spPr>
          <a:xfrm>
            <a:off x="1075680" y="2100240"/>
            <a:ext cx="418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64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212"/>
          <p:cNvSpPr/>
          <p:nvPr/>
        </p:nvSpPr>
        <p:spPr>
          <a:xfrm>
            <a:off x="620640" y="119700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100" spc="-1" strike="noStrike">
                <a:solidFill>
                  <a:srgbClr val="000000"/>
                </a:solidFill>
                <a:latin typeface="Arial"/>
              </a:rPr>
              <a:t>MW (kDa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70"/>
          <p:cNvSpPr/>
          <p:nvPr/>
        </p:nvSpPr>
        <p:spPr>
          <a:xfrm>
            <a:off x="2629080" y="2457360"/>
            <a:ext cx="8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ubPC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0"/>
          <p:cNvSpPr/>
          <p:nvPr/>
        </p:nvSpPr>
        <p:spPr>
          <a:xfrm>
            <a:off x="2629080" y="2846520"/>
            <a:ext cx="71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11 CuadroTexto"/>
          <p:cNvSpPr/>
          <p:nvPr/>
        </p:nvSpPr>
        <p:spPr>
          <a:xfrm>
            <a:off x="1130400" y="4121280"/>
            <a:ext cx="34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6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1 CuadroTexto"/>
          <p:cNvSpPr/>
          <p:nvPr/>
        </p:nvSpPr>
        <p:spPr>
          <a:xfrm>
            <a:off x="558360" y="428760"/>
            <a:ext cx="1563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Arial"/>
              </a:rPr>
              <a:t>Additional 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3" descr=""/>
          <p:cNvPicPr/>
          <p:nvPr/>
        </p:nvPicPr>
        <p:blipFill>
          <a:blip r:embed="rId1"/>
          <a:srcRect l="0" t="0" r="70787" b="0"/>
          <a:stretch/>
        </p:blipFill>
        <p:spPr>
          <a:xfrm>
            <a:off x="1405080" y="1285920"/>
            <a:ext cx="1150920" cy="3209760"/>
          </a:xfrm>
          <a:prstGeom prst="rect">
            <a:avLst/>
          </a:prstGeom>
          <a:ln w="0">
            <a:noFill/>
          </a:ln>
        </p:spPr>
      </p:pic>
      <p:sp>
        <p:nvSpPr>
          <p:cNvPr id="55" name="1 CuadroTexto"/>
          <p:cNvSpPr/>
          <p:nvPr/>
        </p:nvSpPr>
        <p:spPr>
          <a:xfrm>
            <a:off x="1735560" y="1046160"/>
            <a:ext cx="38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U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1 CuadroTexto"/>
          <p:cNvSpPr/>
          <p:nvPr/>
        </p:nvSpPr>
        <p:spPr>
          <a:xfrm>
            <a:off x="2091240" y="1046160"/>
            <a:ext cx="40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H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7" name="24 Conector recto de flecha"/>
          <p:cNvCxnSpPr/>
          <p:nvPr/>
        </p:nvCxnSpPr>
        <p:spPr>
          <a:xfrm flipH="1">
            <a:off x="2564640" y="2622240"/>
            <a:ext cx="1436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lg" type="triangle" w="med"/>
          </a:ln>
        </p:spPr>
      </p:cxnSp>
      <p:cxnSp>
        <p:nvCxnSpPr>
          <p:cNvPr id="58" name="25 Conector recto de flecha"/>
          <p:cNvCxnSpPr/>
          <p:nvPr/>
        </p:nvCxnSpPr>
        <p:spPr>
          <a:xfrm flipH="1">
            <a:off x="2564640" y="3003120"/>
            <a:ext cx="1436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lg" type="triangle" w="med"/>
          </a:ln>
        </p:spPr>
      </p:cxnSp>
      <p:sp>
        <p:nvSpPr>
          <p:cNvPr id="59" name="Rectangle 155"/>
          <p:cNvSpPr/>
          <p:nvPr/>
        </p:nvSpPr>
        <p:spPr>
          <a:xfrm>
            <a:off x="549360" y="4585320"/>
            <a:ext cx="590400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gure 2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Whole cell lysate immunoblot allows detection of PCNA monoubiquitination in response to hydroxyurea treatment.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mage of a complete western blot membrane probed with the anti-PCNA antibody PC10 (Santa Cruz Biotechnology Ref: sc-56). A clear single band of the correct size (approximately 30 kDa) is detected in untreated (UT) 293T cells. Following 24 h treatment with 4mM hydroxyurea (HU), a second band, with a higher molecular weight (approximately 38 kDa, the expected size of monoubiquitinated PCNA) is readily detecte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7T13:18:08Z</dcterms:created>
  <dc:creator>UPV / EHU</dc:creator>
  <dc:description/>
  <dc:language>en-US</dc:language>
  <cp:lastModifiedBy>UPV / EHU</cp:lastModifiedBy>
  <dcterms:modified xsi:type="dcterms:W3CDTF">2014-12-19T11:17:25Z</dcterms:modified>
  <cp:revision>20</cp:revision>
  <dc:subject/>
  <dc:title>Diapositiva 1</dc:title>
</cp:coreProperties>
</file>